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92" r:id="rId2"/>
  </p:sldIdLst>
  <p:sldSz cx="7559675" cy="10439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EFDE27-64D2-9A47-7EBA-F4D877437D86}" name="Crevel, Reinout van" initials="" userId="S::Reinout.vanCrevel@radboudumc.nl::c8a85eab-04e2-4374-80ac-ff56393b1662" providerId="AD"/>
  <p188:author id="{0A69D33C-A3AE-B2FD-DAE3-489C6085493B}" name="Setiabudiawan, Todia" initials="TS" userId="S::Todia.Setiabudiawan@radboudumc.nl::b66113ee-6b80-4b22-902e-4e4411cc18e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7335"/>
    <p:restoredTop sz="94720"/>
  </p:normalViewPr>
  <p:slideViewPr>
    <p:cSldViewPr snapToGrid="0">
      <p:cViewPr varScale="1">
        <p:scale>
          <a:sx n="67" d="100"/>
          <a:sy n="67" d="100"/>
        </p:scale>
        <p:origin x="24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D36B6E-0244-7342-9A93-7D998A0B8A7C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6B7A9C-8B5B-7A4D-836E-05FD47B04D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4364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011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777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884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55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>
                    <a:tint val="82000"/>
                  </a:schemeClr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82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82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7116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748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129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5652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88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21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803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25AF6C-FB27-8745-974A-2E4A52BDC700}" type="datetimeFigureOut">
              <a:rPr lang="en-US" smtClean="0"/>
              <a:t>3/3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D242D6-3047-7841-9009-17DB64648C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421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CB27839-899B-1466-D40F-C5D1D6B63330}"/>
              </a:ext>
            </a:extLst>
          </p:cNvPr>
          <p:cNvGraphicFramePr>
            <a:graphicFrameLocks noGrp="1"/>
          </p:cNvGraphicFramePr>
          <p:nvPr/>
        </p:nvGraphicFramePr>
        <p:xfrm>
          <a:off x="1196956" y="3076947"/>
          <a:ext cx="5165771" cy="3307886"/>
        </p:xfrm>
        <a:graphic>
          <a:graphicData uri="http://schemas.openxmlformats.org/drawingml/2006/table">
            <a:tbl>
              <a:tblPr/>
              <a:tblGrid>
                <a:gridCol w="2085822">
                  <a:extLst>
                    <a:ext uri="{9D8B030D-6E8A-4147-A177-3AD203B41FA5}">
                      <a16:colId xmlns:a16="http://schemas.microsoft.com/office/drawing/2014/main" val="569669189"/>
                    </a:ext>
                  </a:extLst>
                </a:gridCol>
                <a:gridCol w="1175331">
                  <a:extLst>
                    <a:ext uri="{9D8B030D-6E8A-4147-A177-3AD203B41FA5}">
                      <a16:colId xmlns:a16="http://schemas.microsoft.com/office/drawing/2014/main" val="2490371712"/>
                    </a:ext>
                  </a:extLst>
                </a:gridCol>
                <a:gridCol w="1175331">
                  <a:extLst>
                    <a:ext uri="{9D8B030D-6E8A-4147-A177-3AD203B41FA5}">
                      <a16:colId xmlns:a16="http://schemas.microsoft.com/office/drawing/2014/main" val="3737571542"/>
                    </a:ext>
                  </a:extLst>
                </a:gridCol>
                <a:gridCol w="729287">
                  <a:extLst>
                    <a:ext uri="{9D8B030D-6E8A-4147-A177-3AD203B41FA5}">
                      <a16:colId xmlns:a16="http://schemas.microsoft.com/office/drawing/2014/main" val="4187599200"/>
                    </a:ext>
                  </a:extLst>
                </a:gridCol>
              </a:tblGrid>
              <a:tr h="768633">
                <a:tc>
                  <a:txBody>
                    <a:bodyPr/>
                    <a:lstStyle/>
                    <a:p>
                      <a:pPr algn="l" fontAlgn="b">
                        <a:buNone/>
                      </a:pPr>
                      <a:endParaRPr lang="en-GB" sz="900" b="0">
                        <a:solidFill>
                          <a:srgbClr val="333333"/>
                        </a:solidFill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50189" marB="6022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Contacts exposed to</a:t>
                      </a:r>
                      <a:br>
                        <a:rPr lang="en-US" sz="900" b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</a:br>
                      <a:r>
                        <a:rPr lang="en-US" sz="900" b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L2 East-Asian</a:t>
                      </a:r>
                      <a:br>
                        <a:rPr lang="en-US" sz="900" b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</a:br>
                      <a:r>
                        <a:rPr lang="en-US" sz="900" b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(Non-Beijing)</a:t>
                      </a:r>
                      <a:br>
                        <a:rPr lang="en-GB" sz="900" b="0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</a:br>
                      <a:r>
                        <a:rPr lang="en-GB" sz="900" b="0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N = 6</a:t>
                      </a:r>
                      <a:r>
                        <a:rPr lang="en-GB" sz="900" b="0" i="1" baseline="30000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1</a:t>
                      </a:r>
                      <a:endParaRPr lang="en-GB" sz="900" b="0" dirty="0">
                        <a:solidFill>
                          <a:srgbClr val="333333"/>
                        </a:solidFill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50189" marB="6022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900" b="1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Contacts exposed to</a:t>
                      </a:r>
                      <a:br>
                        <a:rPr lang="en-US" sz="900" b="1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</a:br>
                      <a:r>
                        <a:rPr lang="en-US" sz="900" b="1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L2 East-Asian (Beijing)</a:t>
                      </a:r>
                      <a:br>
                        <a:rPr lang="en-GB" sz="900" b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</a:br>
                      <a:r>
                        <a:rPr lang="en-GB" sz="900" b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N = 108</a:t>
                      </a:r>
                      <a:r>
                        <a:rPr lang="en-GB" sz="900" b="0" i="1" baseline="3000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1</a:t>
                      </a:r>
                      <a:endParaRPr lang="en-GB" sz="900" b="0">
                        <a:solidFill>
                          <a:srgbClr val="333333"/>
                        </a:solidFill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50189" marB="6022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GB" sz="900" b="1" i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P</a:t>
                      </a:r>
                      <a:r>
                        <a:rPr lang="en-GB" sz="900" b="1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 value</a:t>
                      </a:r>
                      <a:r>
                        <a:rPr lang="en-GB" sz="900" b="0" i="1" baseline="30000" dirty="0">
                          <a:solidFill>
                            <a:srgbClr val="333333"/>
                          </a:solidFill>
                          <a:effectLst/>
                          <a:latin typeface="HelveticaNeueLT Std" panose="020B0604020202020204" pitchFamily="34" charset="0"/>
                        </a:rPr>
                        <a:t>2</a:t>
                      </a:r>
                      <a:endParaRPr lang="en-GB" sz="900" b="0" dirty="0">
                        <a:solidFill>
                          <a:srgbClr val="333333"/>
                        </a:solidFill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50189" marB="60227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151935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GB" sz="900">
                          <a:effectLst/>
                          <a:latin typeface="HelveticaNeueLT Std" panose="020B0604020202020204" pitchFamily="34" charset="0"/>
                        </a:rPr>
                        <a:t>IGRA status of household contacts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0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9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3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3517494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GB" sz="900" i="1">
                          <a:effectLst/>
                          <a:latin typeface="HelveticaNeueLT Std" panose="020B0604020202020204" pitchFamily="34" charset="0"/>
                        </a:rPr>
                        <a:t>    IGRA converter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 (0%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39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 (3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6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%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7447403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GB" sz="900" i="1">
                          <a:effectLst/>
                          <a:latin typeface="HelveticaNeueLT Std" panose="020B0604020202020204" pitchFamily="34" charset="0"/>
                        </a:rPr>
                        <a:t>    Early clearer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6 (100%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69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 (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64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%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0704293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GB" sz="900">
                          <a:effectLst/>
                          <a:latin typeface="HelveticaNeueLT Std" panose="020B0604020202020204" pitchFamily="34" charset="0"/>
                        </a:rPr>
                        <a:t>Baseline TB-Antigen Response (IU/mL)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07 (0.00, 0.12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02 (-0.0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2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, 0.18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&gt;0.9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70332350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Follow-up TB-Antigen Response (IU/mL)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-0.08 (-0.20, -0.01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1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3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 (0.0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0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, 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1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.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04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00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1</a:t>
                      </a: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9708175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GB" sz="900">
                          <a:effectLst/>
                          <a:latin typeface="HelveticaNeueLT Std" panose="020B0604020202020204" pitchFamily="34" charset="0"/>
                        </a:rPr>
                        <a:t>Baseline Mitogen Response (IU/mL)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6.80 (5.38, 10.00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9.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20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 (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3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.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82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, 10.00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&gt;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9</a:t>
                      </a: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1305120"/>
                  </a:ext>
                </a:extLst>
              </a:tr>
              <a:tr h="292249">
                <a:tc>
                  <a:txBody>
                    <a:bodyPr/>
                    <a:lstStyle/>
                    <a:p>
                      <a:pPr algn="l" fontAlgn="ctr">
                        <a:spcBef>
                          <a:spcPts val="750"/>
                        </a:spcBef>
                        <a:spcAft>
                          <a:spcPts val="750"/>
                        </a:spcAft>
                      </a:pP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Follow-up Mitogen Response (IU/mL)</a:t>
                      </a:r>
                    </a:p>
                  </a:txBody>
                  <a:tcPr marL="30444" marR="30444" marT="48710" marB="48710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6.35 (1.87, 10.00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10.00 (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3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.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21</a:t>
                      </a: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, 10.00)</a:t>
                      </a: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spcBef>
                          <a:spcPts val="750"/>
                        </a:spcBef>
                        <a:spcAft>
                          <a:spcPts val="750"/>
                        </a:spcAft>
                        <a:buNone/>
                      </a:pPr>
                      <a:r>
                        <a:rPr lang="en-NL" sz="900">
                          <a:effectLst/>
                          <a:latin typeface="HelveticaNeueLT Std" panose="020B0604020202020204" pitchFamily="34" charset="0"/>
                        </a:rPr>
                        <a:t>0.</a:t>
                      </a:r>
                      <a:r>
                        <a:rPr lang="en-US" sz="900">
                          <a:effectLst/>
                          <a:latin typeface="HelveticaNeueLT Std" panose="020B0604020202020204" pitchFamily="34" charset="0"/>
                        </a:rPr>
                        <a:t>5</a:t>
                      </a:r>
                      <a:endParaRPr lang="en-NL" sz="900">
                        <a:effectLst/>
                        <a:latin typeface="HelveticaNeueLT Std" panose="020B0604020202020204" pitchFamily="34" charset="0"/>
                      </a:endParaRPr>
                    </a:p>
                  </a:txBody>
                  <a:tcPr marL="50189" marR="50189" marT="80303" marB="80303" anchor="ctr">
                    <a:lnL>
                      <a:noFill/>
                    </a:lnL>
                    <a:lnR>
                      <a:noFill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0256022"/>
                  </a:ext>
                </a:extLst>
              </a:tr>
              <a:tr h="176667">
                <a:tc gridSpan="4"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pt-BR" sz="600" b="0" i="1" baseline="30000">
                          <a:effectLst/>
                          <a:latin typeface="HelveticaNeueLT Std" panose="020B0604020202020204" pitchFamily="34" charset="0"/>
                        </a:rPr>
                        <a:t>1</a:t>
                      </a:r>
                      <a:r>
                        <a:rPr lang="pt-BR" sz="600">
                          <a:effectLst/>
                          <a:latin typeface="HelveticaNeueLT Std" panose="020B0604020202020204" pitchFamily="34" charset="0"/>
                        </a:rPr>
                        <a:t> n (%); Median (Q1, Q3)</a:t>
                      </a:r>
                    </a:p>
                  </a:txBody>
                  <a:tcPr marL="50189" marR="50189" marT="40152" marB="40152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774029578"/>
                  </a:ext>
                </a:extLst>
              </a:tr>
              <a:tr h="176667">
                <a:tc gridSpan="4">
                  <a:txBody>
                    <a:bodyPr/>
                    <a:lstStyle/>
                    <a:p>
                      <a:pPr>
                        <a:buNone/>
                      </a:pPr>
                      <a:r>
                        <a:rPr lang="en-US" sz="600" b="0" i="1" baseline="30000" dirty="0">
                          <a:effectLst/>
                          <a:latin typeface="HelveticaNeueLT Std" panose="020B0604020202020204" pitchFamily="34" charset="0"/>
                        </a:rPr>
                        <a:t>2</a:t>
                      </a:r>
                      <a:r>
                        <a:rPr lang="en-US" sz="600" dirty="0">
                          <a:effectLst/>
                          <a:latin typeface="HelveticaNeueLT Std" panose="020B0604020202020204" pitchFamily="34" charset="0"/>
                        </a:rPr>
                        <a:t> Fisher’s exact test; Wilcoxon rank sum test</a:t>
                      </a:r>
                    </a:p>
                  </a:txBody>
                  <a:tcPr marL="50189" marR="50189" marT="40152" marB="40152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55402494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C34538C-4DAA-DA69-4F18-37BE9CEA21FE}"/>
              </a:ext>
            </a:extLst>
          </p:cNvPr>
          <p:cNvSpPr txBox="1"/>
          <p:nvPr/>
        </p:nvSpPr>
        <p:spPr>
          <a:xfrm>
            <a:off x="535290" y="2822390"/>
            <a:ext cx="6601487" cy="2545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</a:t>
            </a:r>
            <a:r>
              <a:rPr lang="en-US" sz="1054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054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054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IGRA outcome proportion and quantitative IGRA among L2 exposed contact</a:t>
            </a:r>
          </a:p>
        </p:txBody>
      </p:sp>
    </p:spTree>
    <p:extLst>
      <p:ext uri="{BB962C8B-B14F-4D97-AF65-F5344CB8AC3E}">
        <p14:creationId xmlns:p14="http://schemas.microsoft.com/office/powerpoint/2010/main" val="12449035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48</TotalTime>
  <Words>195</Words>
  <Application>Microsoft Macintosh PowerPoint</Application>
  <PresentationFormat>Custom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HelveticaNeueLT Std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omi Daniels</dc:creator>
  <cp:lastModifiedBy>Naomi Daniels</cp:lastModifiedBy>
  <cp:revision>5</cp:revision>
  <dcterms:created xsi:type="dcterms:W3CDTF">2025-04-08T03:28:33Z</dcterms:created>
  <dcterms:modified xsi:type="dcterms:W3CDTF">2026-03-30T03:32:21Z</dcterms:modified>
</cp:coreProperties>
</file>